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22"/>
    <p:restoredTop sz="96405"/>
  </p:normalViewPr>
  <p:slideViewPr>
    <p:cSldViewPr snapToGrid="0">
      <p:cViewPr varScale="1">
        <p:scale>
          <a:sx n="96" d="100"/>
          <a:sy n="96" d="100"/>
        </p:scale>
        <p:origin x="2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C4F57C-DB5B-3FD8-1AB1-AA7C130E18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764EB9B-3CDB-21FF-A0DC-A04EDA4CCC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2448" y="265825"/>
            <a:ext cx="3672000" cy="3672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2C41CA16-EF53-C9B4-C062-7BF5796567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2448" y="4185038"/>
            <a:ext cx="3672000" cy="3672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D024A01-9ACC-4FF0-041F-32F99DAF6E01}"/>
              </a:ext>
            </a:extLst>
          </p:cNvPr>
          <p:cNvSpPr txBox="1"/>
          <p:nvPr/>
        </p:nvSpPr>
        <p:spPr>
          <a:xfrm>
            <a:off x="5055555" y="675015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BR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523A71B-53DE-8D3A-95CB-049CF109EA00}"/>
              </a:ext>
            </a:extLst>
          </p:cNvPr>
          <p:cNvSpPr txBox="1"/>
          <p:nvPr/>
        </p:nvSpPr>
        <p:spPr>
          <a:xfrm>
            <a:off x="5055555" y="1896909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KMT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82C06ED-E745-1F94-D616-111C8B361426}"/>
              </a:ext>
            </a:extLst>
          </p:cNvPr>
          <p:cNvSpPr txBox="1"/>
          <p:nvPr/>
        </p:nvSpPr>
        <p:spPr>
          <a:xfrm>
            <a:off x="5055555" y="3118803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YG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3A89157-1ADB-CB8F-6920-888E5CED11CA}"/>
              </a:ext>
            </a:extLst>
          </p:cNvPr>
          <p:cNvSpPr txBox="1"/>
          <p:nvPr/>
        </p:nvSpPr>
        <p:spPr>
          <a:xfrm>
            <a:off x="5052281" y="4697274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BR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7FE165F-F266-8E37-2A75-79199FBAF586}"/>
              </a:ext>
            </a:extLst>
          </p:cNvPr>
          <p:cNvSpPr txBox="1"/>
          <p:nvPr/>
        </p:nvSpPr>
        <p:spPr>
          <a:xfrm>
            <a:off x="5052281" y="5919168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KMT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C6B9370-997D-A100-D524-39B36122DA2F}"/>
              </a:ext>
            </a:extLst>
          </p:cNvPr>
          <p:cNvSpPr txBox="1"/>
          <p:nvPr/>
        </p:nvSpPr>
        <p:spPr>
          <a:xfrm>
            <a:off x="5052281" y="7141062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YG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D548DB7-17EB-593C-4636-B986D7BFEBB6}"/>
              </a:ext>
            </a:extLst>
          </p:cNvPr>
          <p:cNvSpPr txBox="1"/>
          <p:nvPr/>
        </p:nvSpPr>
        <p:spPr>
          <a:xfrm>
            <a:off x="931305" y="7980869"/>
            <a:ext cx="53028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 Weather conditions for 30 days before samplin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x air temperature of the day, (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precipitation of the day. Weather data for each common garden obtained from AMGSD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[30]. 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676D363-E282-854A-3582-1C4943471A60}"/>
              </a:ext>
            </a:extLst>
          </p:cNvPr>
          <p:cNvSpPr txBox="1"/>
          <p:nvPr/>
        </p:nvSpPr>
        <p:spPr>
          <a:xfrm>
            <a:off x="903562" y="521126"/>
            <a:ext cx="55888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0193806-43DD-3E54-EA99-14DF5641C639}"/>
              </a:ext>
            </a:extLst>
          </p:cNvPr>
          <p:cNvSpPr txBox="1"/>
          <p:nvPr/>
        </p:nvSpPr>
        <p:spPr>
          <a:xfrm>
            <a:off x="903562" y="4418111"/>
            <a:ext cx="55888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B)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0060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894</TotalTime>
  <Words>54</Words>
  <Application>Microsoft Macintosh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1</cp:revision>
  <cp:lastPrinted>2023-10-10T08:11:58Z</cp:lastPrinted>
  <dcterms:created xsi:type="dcterms:W3CDTF">2023-07-12T06:47:41Z</dcterms:created>
  <dcterms:modified xsi:type="dcterms:W3CDTF">2025-08-29T04:54:32Z</dcterms:modified>
  <cp:category/>
</cp:coreProperties>
</file>